
<file path=[Content_Types].xml><?xml version="1.0" encoding="utf-8"?>
<Types xmlns="http://schemas.openxmlformats.org/package/2006/content-types">
  <Override PartName="/ppt/slideMasters/slideMaster2.xml" ContentType="application/vnd.openxmlformats-officedocument.presentationml.slideMaster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2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7"/>
  </p:notesMasterIdLst>
  <p:sldIdLst>
    <p:sldId id="258" r:id="rId3"/>
    <p:sldId id="256" r:id="rId4"/>
    <p:sldId id="271" r:id="rId5"/>
    <p:sldId id="26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-900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bleStyles" Target="tableStyles.xml"/><Relationship Id="rId5" Type="http://schemas.openxmlformats.org/officeDocument/2006/relationships/slide" Target="slides/slide3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7A8E455-E7D2-4838-A195-89F0101616D1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19138E8-D0A9-4F5E-9982-76C20DCFDE6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119488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19138E8-D0A9-4F5E-9982-76C20DCFDE66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4147434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919138E8-D0A9-4F5E-9982-76C20DCFDE66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4052252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6AC7D4C4-CC7F-67A1-BDB3-5C387CB55B0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EFE49B33-3619-EA76-48EF-2AFE17A200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FFB209F7-B980-5CD1-1861-9C30E25177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3453-38C2-49AB-9304-36821EB9EF20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15131F04-FE4E-66BF-D9CE-8374230850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A5FD4BC5-CFA6-4F51-DB84-C0CD248C4C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66687-EC50-497C-8117-06F229994A4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15897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8E5CBBD-F4A7-E4EA-CA2A-5484BEE461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9D45484B-BEF6-3924-40B4-4B35C443C9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C94F2A3A-86FD-A644-D840-6DE313702F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3453-38C2-49AB-9304-36821EB9EF20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4F266DB5-39F2-E684-E898-83808FC69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98F4AC8-29AC-B11F-823E-14D667DFDD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66687-EC50-497C-8117-06F229994A4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857135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11207921-CF1D-B419-0948-8F76E86EEA7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45FA6BA1-F2D9-89A4-0F11-DF9EAA8D09F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904739DF-6F74-C89F-CB6C-72CEE723C2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3453-38C2-49AB-9304-36821EB9EF20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C3BD3431-9336-08B3-A3EE-5F75C9010E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4FF36247-10B4-07B6-9998-A6FCEE1AD2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66687-EC50-497C-8117-06F229994A4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2411739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7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6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58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5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4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245B1-033E-48FA-903A-9A343F188B1B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E861-A6FA-4E3C-A049-8465177E8D4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245930530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245B1-033E-48FA-903A-9A343F188B1B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E861-A6FA-4E3C-A049-8465177E8D4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8913888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4"/>
            <a:ext cx="10363200" cy="150018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31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6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94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725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656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587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518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45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245B1-033E-48FA-903A-9A343F188B1B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E861-A6FA-4E3C-A049-8465177E8D4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35723606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245B1-033E-48FA-903A-9A343F188B1B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E861-A6FA-4E3C-A049-8465177E8D4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67698374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8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31" indent="0">
              <a:buNone/>
              <a:defRPr sz="1500" b="1"/>
            </a:lvl2pPr>
            <a:lvl3pPr marL="685863" indent="0">
              <a:buNone/>
              <a:defRPr sz="1350" b="1"/>
            </a:lvl3pPr>
            <a:lvl4pPr marL="1028794" indent="0">
              <a:buNone/>
              <a:defRPr sz="1200" b="1"/>
            </a:lvl4pPr>
            <a:lvl5pPr marL="1371725" indent="0">
              <a:buNone/>
              <a:defRPr sz="1200" b="1"/>
            </a:lvl5pPr>
            <a:lvl6pPr marL="1714656" indent="0">
              <a:buNone/>
              <a:defRPr sz="1200" b="1"/>
            </a:lvl6pPr>
            <a:lvl7pPr marL="2057587" indent="0">
              <a:buNone/>
              <a:defRPr sz="1200" b="1"/>
            </a:lvl7pPr>
            <a:lvl8pPr marL="2400518" indent="0">
              <a:buNone/>
              <a:defRPr sz="1200" b="1"/>
            </a:lvl8pPr>
            <a:lvl9pPr marL="274345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8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31" indent="0">
              <a:buNone/>
              <a:defRPr sz="1500" b="1"/>
            </a:lvl2pPr>
            <a:lvl3pPr marL="685863" indent="0">
              <a:buNone/>
              <a:defRPr sz="1350" b="1"/>
            </a:lvl3pPr>
            <a:lvl4pPr marL="1028794" indent="0">
              <a:buNone/>
              <a:defRPr sz="1200" b="1"/>
            </a:lvl4pPr>
            <a:lvl5pPr marL="1371725" indent="0">
              <a:buNone/>
              <a:defRPr sz="1200" b="1"/>
            </a:lvl5pPr>
            <a:lvl6pPr marL="1714656" indent="0">
              <a:buNone/>
              <a:defRPr sz="1200" b="1"/>
            </a:lvl6pPr>
            <a:lvl7pPr marL="2057587" indent="0">
              <a:buNone/>
              <a:defRPr sz="1200" b="1"/>
            </a:lvl7pPr>
            <a:lvl8pPr marL="2400518" indent="0">
              <a:buNone/>
              <a:defRPr sz="1200" b="1"/>
            </a:lvl8pPr>
            <a:lvl9pPr marL="274345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245B1-033E-48FA-903A-9A343F188B1B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E861-A6FA-4E3C-A049-8465177E8D4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60672934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245B1-033E-48FA-903A-9A343F188B1B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E861-A6FA-4E3C-A049-8465177E8D4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02344736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245B1-033E-48FA-903A-9A343F188B1B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E861-A6FA-4E3C-A049-8465177E8D4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472757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050"/>
            </a:lvl1pPr>
            <a:lvl2pPr marL="342931" indent="0">
              <a:buNone/>
              <a:defRPr sz="900"/>
            </a:lvl2pPr>
            <a:lvl3pPr marL="685863" indent="0">
              <a:buNone/>
              <a:defRPr sz="750"/>
            </a:lvl3pPr>
            <a:lvl4pPr marL="1028794" indent="0">
              <a:buNone/>
              <a:defRPr sz="675"/>
            </a:lvl4pPr>
            <a:lvl5pPr marL="1371725" indent="0">
              <a:buNone/>
              <a:defRPr sz="675"/>
            </a:lvl5pPr>
            <a:lvl6pPr marL="1714656" indent="0">
              <a:buNone/>
              <a:defRPr sz="675"/>
            </a:lvl6pPr>
            <a:lvl7pPr marL="2057587" indent="0">
              <a:buNone/>
              <a:defRPr sz="675"/>
            </a:lvl7pPr>
            <a:lvl8pPr marL="2400518" indent="0">
              <a:buNone/>
              <a:defRPr sz="675"/>
            </a:lvl8pPr>
            <a:lvl9pPr marL="274345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245B1-033E-48FA-903A-9A343F188B1B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E861-A6FA-4E3C-A049-8465177E8D4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1496787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F81A8273-C489-B38F-DA6E-1122210B498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D6487C1A-870A-4D1D-F248-9B70F3F4DF3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7F52E854-5FB1-6281-7793-DAD10CC59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3453-38C2-49AB-9304-36821EB9EF20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2CDB0129-6C6B-5913-DEC2-9ADC13034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0BE67198-A86A-FC90-15F1-32CC722045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66687-EC50-497C-8117-06F229994A4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395362014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8" y="4800601"/>
            <a:ext cx="7315200" cy="566738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8" y="612775"/>
            <a:ext cx="7315200" cy="4114800"/>
          </a:xfrm>
        </p:spPr>
        <p:txBody>
          <a:bodyPr/>
          <a:lstStyle>
            <a:lvl1pPr marL="0" indent="0">
              <a:buNone/>
              <a:defRPr sz="2400"/>
            </a:lvl1pPr>
            <a:lvl2pPr marL="342931" indent="0">
              <a:buNone/>
              <a:defRPr sz="2100"/>
            </a:lvl2pPr>
            <a:lvl3pPr marL="685863" indent="0">
              <a:buNone/>
              <a:defRPr sz="1800"/>
            </a:lvl3pPr>
            <a:lvl4pPr marL="1028794" indent="0">
              <a:buNone/>
              <a:defRPr sz="1500"/>
            </a:lvl4pPr>
            <a:lvl5pPr marL="1371725" indent="0">
              <a:buNone/>
              <a:defRPr sz="1500"/>
            </a:lvl5pPr>
            <a:lvl6pPr marL="1714656" indent="0">
              <a:buNone/>
              <a:defRPr sz="1500"/>
            </a:lvl6pPr>
            <a:lvl7pPr marL="2057587" indent="0">
              <a:buNone/>
              <a:defRPr sz="1500"/>
            </a:lvl7pPr>
            <a:lvl8pPr marL="2400518" indent="0">
              <a:buNone/>
              <a:defRPr sz="1500"/>
            </a:lvl8pPr>
            <a:lvl9pPr marL="274345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8" y="5367339"/>
            <a:ext cx="7315200" cy="804862"/>
          </a:xfrm>
        </p:spPr>
        <p:txBody>
          <a:bodyPr/>
          <a:lstStyle>
            <a:lvl1pPr marL="0" indent="0">
              <a:buNone/>
              <a:defRPr sz="1050"/>
            </a:lvl1pPr>
            <a:lvl2pPr marL="342931" indent="0">
              <a:buNone/>
              <a:defRPr sz="900"/>
            </a:lvl2pPr>
            <a:lvl3pPr marL="685863" indent="0">
              <a:buNone/>
              <a:defRPr sz="750"/>
            </a:lvl3pPr>
            <a:lvl4pPr marL="1028794" indent="0">
              <a:buNone/>
              <a:defRPr sz="675"/>
            </a:lvl4pPr>
            <a:lvl5pPr marL="1371725" indent="0">
              <a:buNone/>
              <a:defRPr sz="675"/>
            </a:lvl5pPr>
            <a:lvl6pPr marL="1714656" indent="0">
              <a:buNone/>
              <a:defRPr sz="675"/>
            </a:lvl6pPr>
            <a:lvl7pPr marL="2057587" indent="0">
              <a:buNone/>
              <a:defRPr sz="675"/>
            </a:lvl7pPr>
            <a:lvl8pPr marL="2400518" indent="0">
              <a:buNone/>
              <a:defRPr sz="675"/>
            </a:lvl8pPr>
            <a:lvl9pPr marL="2743450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245B1-033E-48FA-903A-9A343F188B1B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E861-A6FA-4E3C-A049-8465177E8D4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226721051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245B1-033E-48FA-903A-9A343F188B1B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E861-A6FA-4E3C-A049-8465177E8D4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62972221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245B1-033E-48FA-903A-9A343F188B1B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0EE861-A6FA-4E3C-A049-8465177E8D4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60332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1EBFBEE-B5AB-8BA2-EB58-139FCE6980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E62E5299-D515-C88D-C6D7-63D6B65B5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04F449FD-06CA-D5F4-1680-CCE63E5EC8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3453-38C2-49AB-9304-36821EB9EF20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09E9CF65-6F4E-6A60-C640-91242150A5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F3251505-4682-64D0-38D7-512B7856D9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66687-EC50-497C-8117-06F229994A4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5172291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10356E4-BC24-3FFE-69EE-19DD39399A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425B19CF-BBAF-9B7E-7A47-83B55C1C60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E86D0C86-E33A-F8F7-C614-586B60E9A7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728AA609-03B8-DAEC-4573-7DD644D563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3453-38C2-49AB-9304-36821EB9EF20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2B0C67CA-0E07-1533-9F4A-66BC31E442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474AA3C2-E64B-448B-18D4-A296108CC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66687-EC50-497C-8117-06F229994A4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905995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FAA4F6E2-052A-6883-B226-32B7551FDB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7320E1D3-F578-4D1A-5110-17B7027734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59307092-74EC-6E73-AC33-033C84340D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6B65092E-EB44-227E-866D-50DE66827D8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39379D1D-F225-D589-D6B1-6BCCF9337A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A149E829-EC58-4407-AC60-59B356C75B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3453-38C2-49AB-9304-36821EB9EF20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1805F5A0-EFD7-98E6-FC70-5016F8190B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E64FDD54-7D56-A1DC-B75E-DEE225151B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66687-EC50-497C-8117-06F229994A4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519443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FDACFEA0-9062-BDD2-B369-DDAB87A84C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AFA85F8F-CAA0-FF94-88A0-275D97F54B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3453-38C2-49AB-9304-36821EB9EF20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2B1967FD-0022-5328-5EBE-89E010423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FF9DBA41-C4C2-78B6-A896-008EB0FB5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66687-EC50-497C-8117-06F229994A4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022791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2E31033E-627F-E552-6416-336C175765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3453-38C2-49AB-9304-36821EB9EF20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141CB8D0-8C3F-F61E-F069-FDD27536A8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903BCB06-295C-40D6-3634-2431068EBD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66687-EC50-497C-8117-06F229994A4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0714615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822968B7-B5C7-EBB3-D5D7-70C631C2F4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D6309AD8-FD31-9A75-C35B-10D23000DA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03155C10-B18D-5A1D-C0D7-87033241B4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082CC145-FBE8-A5F8-B256-24D3BC4EEF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3453-38C2-49AB-9304-36821EB9EF20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95467243-F7B7-CF59-6B4C-8C76A8FD5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362839FC-09C8-56B5-C5FB-05CA7BA49D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66687-EC50-497C-8117-06F229994A4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243395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8394C46-C3FF-C825-F09C-E35F9C7510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FDD357A1-899F-572D-8CAF-0B7A6C9F3B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6A88ED79-BAE2-8476-B080-4FA4F57270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2714A631-775A-7F35-7909-9D29008C0A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213453-38C2-49AB-9304-36821EB9EF20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ED7F3949-D41E-0EF8-E43D-6BE274118F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466EC606-0E65-9018-D416-819EE9B7FC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C66687-EC50-497C-8117-06F229994A4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732741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D8CF70B0-E64E-1291-DFF1-27DAD0EFBC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989F11A6-DDDB-3CAF-C4A6-1CB9A5865E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BDB976B-713C-9A4E-CA5D-C7A9EF209F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213453-38C2-49AB-9304-36821EB9EF20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5F92DCAE-729C-FDB4-FD3B-4011FE9F8AB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68335CA1-4B7D-1EF1-384B-BE19247C102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C66687-EC50-497C-8117-06F229994A4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240643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245B1-033E-48FA-903A-9A343F188B1B}" type="datetimeFigureOut">
              <a:rPr lang="en-US" smtClean="0"/>
              <a:pPr/>
              <a:t>12/2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0EE861-A6FA-4E3C-A049-8465177E8D4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973255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685863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99" indent="-257199" algn="l" defTabSz="685863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63" indent="-214332" algn="l" defTabSz="685863" rtl="0" eaLnBrk="1" latinLnBrk="0" hangingPunct="1">
        <a:spcBef>
          <a:spcPct val="20000"/>
        </a:spcBef>
        <a:buFont typeface="Arial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328" indent="-171465" algn="l" defTabSz="685863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259" indent="-171465" algn="l" defTabSz="685863" rtl="0" eaLnBrk="1" latinLnBrk="0" hangingPunct="1">
        <a:spcBef>
          <a:spcPct val="20000"/>
        </a:spcBef>
        <a:buFont typeface="Arial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190" indent="-171465" algn="l" defTabSz="685863" rtl="0" eaLnBrk="1" latinLnBrk="0" hangingPunct="1">
        <a:spcBef>
          <a:spcPct val="20000"/>
        </a:spcBef>
        <a:buFont typeface="Arial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6122" indent="-171465" algn="l" defTabSz="685863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9053" indent="-171465" algn="l" defTabSz="685863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984" indent="-171465" algn="l" defTabSz="685863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915" indent="-171465" algn="l" defTabSz="685863" rtl="0" eaLnBrk="1" latinLnBrk="0" hangingPunct="1">
        <a:spcBef>
          <a:spcPct val="20000"/>
        </a:spcBef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6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31" algn="l" defTabSz="68586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63" algn="l" defTabSz="68586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94" algn="l" defTabSz="68586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725" algn="l" defTabSz="68586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656" algn="l" defTabSz="68586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587" algn="l" defTabSz="68586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518" algn="l" defTabSz="68586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450" algn="l" defTabSz="68586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3.xml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="" xmlns:a16="http://schemas.microsoft.com/office/drawing/2014/main" id="{35790112-BA81-D25A-522C-F2FD8EC4580F}"/>
              </a:ext>
            </a:extLst>
          </p:cNvPr>
          <p:cNvSpPr txBox="1"/>
          <p:nvPr/>
        </p:nvSpPr>
        <p:spPr>
          <a:xfrm>
            <a:off x="71107" y="0"/>
            <a:ext cx="11382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Figure S1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="" xmlns:a16="http://schemas.microsoft.com/office/drawing/2014/main" id="{49CD31AE-B927-0226-1BC9-972FFFD8F4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9677" t="10995" r="21048" b="8530"/>
          <a:stretch/>
        </p:blipFill>
        <p:spPr>
          <a:xfrm>
            <a:off x="1543665" y="127819"/>
            <a:ext cx="9438968" cy="6597445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315539763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="" xmlns:a16="http://schemas.microsoft.com/office/drawing/2014/main" id="{2D0C90D1-C7B8-319A-39F7-81276AF92DFA}"/>
              </a:ext>
            </a:extLst>
          </p:cNvPr>
          <p:cNvSpPr txBox="1"/>
          <p:nvPr/>
        </p:nvSpPr>
        <p:spPr>
          <a:xfrm>
            <a:off x="94694" y="12054"/>
            <a:ext cx="11382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Figure S2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="" xmlns:a16="http://schemas.microsoft.com/office/drawing/2014/main" id="{BAA3080D-7E22-EFBB-4337-9B3CFC589ED8}"/>
              </a:ext>
            </a:extLst>
          </p:cNvPr>
          <p:cNvGrpSpPr/>
          <p:nvPr/>
        </p:nvGrpSpPr>
        <p:grpSpPr>
          <a:xfrm>
            <a:off x="0" y="698091"/>
            <a:ext cx="12192000" cy="6022258"/>
            <a:chOff x="17377" y="1086225"/>
            <a:chExt cx="12192000" cy="5771775"/>
          </a:xfrm>
        </p:grpSpPr>
        <p:pic>
          <p:nvPicPr>
            <p:cNvPr id="1026" name="Picture 2" descr="D:\Laptop files Dec 2018\Labtop files\Graduate students projects\Dr Mahamoud Ashraf\Results\Sequencing results\Phage_1_new_vB_KpnP_KP17_ok\Results by Momen_______OK\Mauve---------------ok\Image.jpg"/>
            <p:cNvPicPr>
              <a:picLocks noChangeAspect="1" noChangeArrowheads="1"/>
            </p:cNvPicPr>
            <p:nvPr/>
          </p:nvPicPr>
          <p:blipFill>
            <a:blip r:embed="rId3"/>
            <a:srcRect/>
            <a:stretch>
              <a:fillRect/>
            </a:stretch>
          </p:blipFill>
          <p:spPr bwMode="auto">
            <a:xfrm>
              <a:off x="17377" y="1086225"/>
              <a:ext cx="12192000" cy="5771775"/>
            </a:xfrm>
            <a:prstGeom prst="rect">
              <a:avLst/>
            </a:prstGeom>
            <a:noFill/>
          </p:spPr>
        </p:pic>
        <p:sp>
          <p:nvSpPr>
            <p:cNvPr id="3" name="TextBox 2">
              <a:extLst>
                <a:ext uri="{FF2B5EF4-FFF2-40B4-BE49-F238E27FC236}">
                  <a16:creationId xmlns="" xmlns:a16="http://schemas.microsoft.com/office/drawing/2014/main" id="{F6175664-D0B8-4F1B-BC6D-9421CF523389}"/>
                </a:ext>
              </a:extLst>
            </p:cNvPr>
            <p:cNvSpPr txBox="1"/>
            <p:nvPr/>
          </p:nvSpPr>
          <p:spPr>
            <a:xfrm>
              <a:off x="4293254" y="1086225"/>
              <a:ext cx="317716" cy="28713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160752"/>
              <a:r>
                <a:rPr lang="en-US" sz="1266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sz="1266" b="1" dirty="0">
                  <a:solidFill>
                    <a:prstClr val="black"/>
                  </a:solidFill>
                  <a:latin typeface="Calibri"/>
                </a:rPr>
                <a:t>)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="" xmlns:a16="http://schemas.microsoft.com/office/drawing/2014/main" id="{EE7EDAFA-E54B-EB60-B3EF-B9DEF3B3D41A}"/>
                </a:ext>
              </a:extLst>
            </p:cNvPr>
            <p:cNvSpPr txBox="1"/>
            <p:nvPr/>
          </p:nvSpPr>
          <p:spPr>
            <a:xfrm>
              <a:off x="238481" y="1457124"/>
              <a:ext cx="2758069" cy="265478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lebsiella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hage vB_KpnP_KP17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="" xmlns:a16="http://schemas.microsoft.com/office/drawing/2014/main" id="{56A0B381-6EC2-423E-7C8E-06F6E355487E}"/>
                </a:ext>
              </a:extLst>
            </p:cNvPr>
            <p:cNvSpPr txBox="1"/>
            <p:nvPr/>
          </p:nvSpPr>
          <p:spPr>
            <a:xfrm>
              <a:off x="207506" y="2090354"/>
              <a:ext cx="2085651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lebsiella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hage KP32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="" xmlns:a16="http://schemas.microsoft.com/office/drawing/2014/main" id="{53A57123-4CFA-3558-26DC-B53CB12FB46F}"/>
                </a:ext>
              </a:extLst>
            </p:cNvPr>
            <p:cNvSpPr txBox="1"/>
            <p:nvPr/>
          </p:nvSpPr>
          <p:spPr>
            <a:xfrm>
              <a:off x="172064" y="2731159"/>
              <a:ext cx="282448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lebsiella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hage vB_Kpn_K37PH164C1 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="" xmlns:a16="http://schemas.microsoft.com/office/drawing/2014/main" id="{A53032B4-8A6B-7DA4-B776-D0E445D3242F}"/>
                </a:ext>
              </a:extLst>
            </p:cNvPr>
            <p:cNvSpPr txBox="1"/>
            <p:nvPr/>
          </p:nvSpPr>
          <p:spPr>
            <a:xfrm>
              <a:off x="179710" y="3371482"/>
              <a:ext cx="1971267" cy="2802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lebsiella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hage Kp9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="" xmlns:a16="http://schemas.microsoft.com/office/drawing/2014/main" id="{7590E0B1-CFE9-2BDE-AD5D-1E5D2FAD0636}"/>
                </a:ext>
              </a:extLst>
            </p:cNvPr>
            <p:cNvSpPr txBox="1"/>
            <p:nvPr/>
          </p:nvSpPr>
          <p:spPr>
            <a:xfrm>
              <a:off x="172065" y="4021955"/>
              <a:ext cx="2824486" cy="2802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lebsiella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hage vB_KpnP_KpV763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="" xmlns:a16="http://schemas.microsoft.com/office/drawing/2014/main" id="{C50E9107-82EE-AB4C-811D-FB1ECAD87FBC}"/>
                </a:ext>
              </a:extLst>
            </p:cNvPr>
            <p:cNvSpPr txBox="1"/>
            <p:nvPr/>
          </p:nvSpPr>
          <p:spPr>
            <a:xfrm>
              <a:off x="179710" y="4655863"/>
              <a:ext cx="253811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lebsiella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hage IME183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="" xmlns:a16="http://schemas.microsoft.com/office/drawing/2014/main" id="{9BA03814-6B42-5F1C-84F6-68EF30F5DD4F}"/>
                </a:ext>
              </a:extLst>
            </p:cNvPr>
            <p:cNvSpPr txBox="1"/>
            <p:nvPr/>
          </p:nvSpPr>
          <p:spPr>
            <a:xfrm>
              <a:off x="172064" y="5292951"/>
              <a:ext cx="282448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lebsiella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hage vB_KpnP_EKp2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="" xmlns:a16="http://schemas.microsoft.com/office/drawing/2014/main" id="{DFDD04F5-2511-22CE-C3E0-989D87CEEB8F}"/>
                </a:ext>
              </a:extLst>
            </p:cNvPr>
            <p:cNvSpPr txBox="1"/>
            <p:nvPr/>
          </p:nvSpPr>
          <p:spPr>
            <a:xfrm>
              <a:off x="172064" y="5933273"/>
              <a:ext cx="282448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lebsiella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hage cp7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="" xmlns:a16="http://schemas.microsoft.com/office/drawing/2014/main" id="{8D4A9EDC-8C60-3BB0-FEB4-25FD8F735ACA}"/>
                </a:ext>
              </a:extLst>
            </p:cNvPr>
            <p:cNvSpPr txBox="1"/>
            <p:nvPr/>
          </p:nvSpPr>
          <p:spPr>
            <a:xfrm>
              <a:off x="172064" y="6573595"/>
              <a:ext cx="282448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Klebsiella</a:t>
              </a:r>
              <a:r>
                <a: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hage Kp11</a:t>
              </a:r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4" name="Picture 2" descr="D:\Laptop files Dec 2018\Labtop files\Graduate students projects\Dr Mahamoud Ashraf\Results\Sequencing results\Phage_1_new_vB_KpnP_KP17_ok\Results by Momen_______OK\vContATCT &amp; Cytoscape_Klebsiella-----------------ok\Images\11.jpeg"/>
          <p:cNvPicPr>
            <a:picLocks noChangeAspect="1" noChangeArrowheads="1"/>
          </p:cNvPicPr>
          <p:nvPr/>
        </p:nvPicPr>
        <p:blipFill>
          <a:blip r:embed="rId3" cstate="print"/>
          <a:srcRect l="20833" r="40000" b="3978"/>
          <a:stretch>
            <a:fillRect/>
          </a:stretch>
        </p:blipFill>
        <p:spPr bwMode="auto">
          <a:xfrm>
            <a:off x="515829" y="835606"/>
            <a:ext cx="4722380" cy="305308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</p:pic>
      <p:pic>
        <p:nvPicPr>
          <p:cNvPr id="13315" name="Picture 3" descr="D:\Laptop files Dec 2018\Labtop files\Graduate students projects\Dr Mahamoud Ashraf\Results\Sequencing results\Phage_1_new_vB_KpnP_KP17_ok\Results by Momen_______OK\vContATCT &amp; Cytoscape_Klebsiella-----------------ok\Images\22.jpe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523827" y="4068778"/>
            <a:ext cx="4706384" cy="281847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</p:pic>
      <p:pic>
        <p:nvPicPr>
          <p:cNvPr id="13316" name="Picture 4" descr="D:\Laptop files Dec 2018\Labtop files\Graduate students projects\Dr Mahamoud Ashraf\Results\Sequencing results\Phage_1_new_vB_KpnP_KP17_ok\Results by Momen_______OK\vContATCT &amp; Cytoscape_Klebsiella-----------------ok\Images\3.jpeg"/>
          <p:cNvPicPr>
            <a:picLocks noChangeAspect="1" noChangeArrowheads="1"/>
          </p:cNvPicPr>
          <p:nvPr/>
        </p:nvPicPr>
        <p:blipFill>
          <a:blip r:embed="rId5" cstate="print"/>
          <a:srcRect l="18333" r="30000"/>
          <a:stretch>
            <a:fillRect/>
          </a:stretch>
        </p:blipFill>
        <p:spPr bwMode="auto">
          <a:xfrm>
            <a:off x="5319253" y="747252"/>
            <a:ext cx="6765202" cy="6032028"/>
          </a:xfrm>
          <a:prstGeom prst="rect">
            <a:avLst/>
          </a:prstGeom>
          <a:noFill/>
        </p:spPr>
      </p:pic>
      <p:sp>
        <p:nvSpPr>
          <p:cNvPr id="3" name="TextBox 2">
            <a:extLst>
              <a:ext uri="{FF2B5EF4-FFF2-40B4-BE49-F238E27FC236}">
                <a16:creationId xmlns="" xmlns:a16="http://schemas.microsoft.com/office/drawing/2014/main" id="{57D64518-0DA8-D6C9-038D-7BAB66CB8377}"/>
              </a:ext>
            </a:extLst>
          </p:cNvPr>
          <p:cNvSpPr txBox="1"/>
          <p:nvPr/>
        </p:nvSpPr>
        <p:spPr>
          <a:xfrm>
            <a:off x="81375" y="0"/>
            <a:ext cx="11382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Figure S3</a:t>
            </a: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825851" y="0"/>
            <a:ext cx="8637283" cy="6858000"/>
            <a:chOff x="0" y="0"/>
            <a:chExt cx="8382000" cy="6858000"/>
          </a:xfrm>
        </p:grpSpPr>
        <p:pic>
          <p:nvPicPr>
            <p:cNvPr id="9218" name="Picture 2"/>
            <p:cNvPicPr>
              <a:picLocks noChangeAspect="1" noChangeArrowheads="1"/>
            </p:cNvPicPr>
            <p:nvPr/>
          </p:nvPicPr>
          <p:blipFill>
            <a:blip r:embed="rId2"/>
            <a:srcRect l="11620" t="2569" r="6143"/>
            <a:stretch>
              <a:fillRect/>
            </a:stretch>
          </p:blipFill>
          <p:spPr bwMode="auto">
            <a:xfrm>
              <a:off x="1143000" y="0"/>
              <a:ext cx="7239000" cy="6858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pic>
          <p:nvPicPr>
            <p:cNvPr id="9219" name="Picture 3"/>
            <p:cNvPicPr>
              <a:picLocks noChangeAspect="1" noChangeArrowheads="1"/>
            </p:cNvPicPr>
            <p:nvPr/>
          </p:nvPicPr>
          <p:blipFill>
            <a:blip r:embed="rId2"/>
            <a:srcRect r="86152" b="88379"/>
            <a:stretch>
              <a:fillRect/>
            </a:stretch>
          </p:blipFill>
          <p:spPr bwMode="auto">
            <a:xfrm>
              <a:off x="0" y="0"/>
              <a:ext cx="1981200" cy="14478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</p:grpSp>
      <p:sp>
        <p:nvSpPr>
          <p:cNvPr id="3" name="TextBox 2">
            <a:extLst>
              <a:ext uri="{FF2B5EF4-FFF2-40B4-BE49-F238E27FC236}">
                <a16:creationId xmlns="" xmlns:a16="http://schemas.microsoft.com/office/drawing/2014/main" id="{5694B31E-CCE9-86CB-E785-3628863A66EF}"/>
              </a:ext>
            </a:extLst>
          </p:cNvPr>
          <p:cNvSpPr txBox="1"/>
          <p:nvPr/>
        </p:nvSpPr>
        <p:spPr>
          <a:xfrm>
            <a:off x="29497" y="0"/>
            <a:ext cx="113826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Figure S4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8</TotalTime>
  <Words>39</Words>
  <Application>Microsoft Office PowerPoint</Application>
  <PresentationFormat>Custom</PresentationFormat>
  <Paragraphs>16</Paragraphs>
  <Slides>4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6" baseType="lpstr">
      <vt:lpstr>Office Theme</vt:lpstr>
      <vt:lpstr>1_Office Them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r. Mahmoud</dc:creator>
  <cp:lastModifiedBy>Momen Askoura</cp:lastModifiedBy>
  <cp:revision>17</cp:revision>
  <dcterms:created xsi:type="dcterms:W3CDTF">2024-08-23T08:57:25Z</dcterms:created>
  <dcterms:modified xsi:type="dcterms:W3CDTF">2024-12-25T08:24:19Z</dcterms:modified>
</cp:coreProperties>
</file>